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24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741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98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905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5667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95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559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762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8960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4019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9268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1066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15E5A-2098-4F22-9095-2DB3D9817F84}" type="datetimeFigureOut">
              <a:rPr lang="zh-CN" altLang="en-US" smtClean="0"/>
              <a:t>2022\11\29 Tue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1B910-0458-43FB-B056-0805F47A95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281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4987" y="5129212"/>
            <a:ext cx="3228975" cy="220027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4987" y="1757721"/>
            <a:ext cx="3208348" cy="2166579"/>
          </a:xfrm>
          <a:prstGeom prst="rect">
            <a:avLst/>
          </a:prstGeom>
        </p:spPr>
      </p:pic>
      <p:grpSp>
        <p:nvGrpSpPr>
          <p:cNvPr id="18" name="组合 17"/>
          <p:cNvGrpSpPr/>
          <p:nvPr/>
        </p:nvGrpSpPr>
        <p:grpSpPr>
          <a:xfrm>
            <a:off x="969903" y="3966210"/>
            <a:ext cx="4056404" cy="455770"/>
            <a:chOff x="969903" y="3966210"/>
            <a:chExt cx="4056404" cy="455770"/>
          </a:xfrm>
        </p:grpSpPr>
        <p:sp>
          <p:nvSpPr>
            <p:cNvPr id="6" name="矩形 5"/>
            <p:cNvSpPr/>
            <p:nvPr/>
          </p:nvSpPr>
          <p:spPr>
            <a:xfrm rot="-2340000">
              <a:off x="969903" y="4175759"/>
              <a:ext cx="12955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ary_Root_3DA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-2340000">
              <a:off x="1429020" y="4109085"/>
              <a:ext cx="1063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ode_6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-2340000">
              <a:off x="1522405" y="4169295"/>
              <a:ext cx="12570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rteenth_Leaf_V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-2340000">
              <a:off x="2039712" y="4080199"/>
              <a:ext cx="94609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_Tip_V5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-2340000">
              <a:off x="2024023" y="4156710"/>
              <a:ext cx="126028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_and_SAM_V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-2340000">
              <a:off x="2275633" y="4156710"/>
              <a:ext cx="126028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_and_SAM_V3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-2340000">
              <a:off x="2931749" y="4023359"/>
              <a:ext cx="80502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ers_R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-2340000">
              <a:off x="2784293" y="4156775"/>
              <a:ext cx="12474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ature_Cob_V1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-2340000">
              <a:off x="3561471" y="3966210"/>
              <a:ext cx="6527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lks_R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-2340000">
              <a:off x="3246009" y="4166268"/>
              <a:ext cx="129073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_Seed_16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-2340000">
              <a:off x="3569476" y="4147186"/>
              <a:ext cx="12186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sperm_14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-2340000">
              <a:off x="3963195" y="4118642"/>
              <a:ext cx="1063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bryo_24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975981" y="7364222"/>
            <a:ext cx="4084979" cy="455770"/>
            <a:chOff x="975981" y="7364222"/>
            <a:chExt cx="4084979" cy="455770"/>
          </a:xfrm>
        </p:grpSpPr>
        <p:sp>
          <p:nvSpPr>
            <p:cNvPr id="20" name="矩形 19"/>
            <p:cNvSpPr/>
            <p:nvPr/>
          </p:nvSpPr>
          <p:spPr>
            <a:xfrm rot="19260000">
              <a:off x="975981" y="7573771"/>
              <a:ext cx="12955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ary_Root_3DAS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260000">
              <a:off x="1435098" y="7507097"/>
              <a:ext cx="1063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ode_6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260000">
              <a:off x="1528483" y="7567307"/>
              <a:ext cx="12570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rteenth_Leaf_VT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260000">
              <a:off x="2045790" y="7478211"/>
              <a:ext cx="94609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_Tip_V5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260000">
              <a:off x="2030101" y="7554722"/>
              <a:ext cx="126028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_and_SAM_V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260000">
              <a:off x="2281711" y="7554722"/>
              <a:ext cx="126028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_and_SAM_V3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260000">
              <a:off x="2937827" y="7421371"/>
              <a:ext cx="80502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ers_R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260000">
              <a:off x="2809421" y="7554787"/>
              <a:ext cx="12474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ature_Cob_V18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260000">
              <a:off x="3596124" y="7364222"/>
              <a:ext cx="6527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lks_R1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260000">
              <a:off x="3271137" y="7564280"/>
              <a:ext cx="129073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_Seed_16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260000">
              <a:off x="3594604" y="7535673"/>
              <a:ext cx="12186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sperm_14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260000">
              <a:off x="3997848" y="7488079"/>
              <a:ext cx="1063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bryo_24DA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文本框 32"/>
          <p:cNvSpPr txBox="1"/>
          <p:nvPr/>
        </p:nvSpPr>
        <p:spPr>
          <a:xfrm>
            <a:off x="1618299" y="712163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561149" y="64290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562054" y="57324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562054" y="50379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636292" y="374047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569617" y="35490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568433" y="33594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576825" y="31124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491100" y="29502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497901" y="267405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497901" y="234092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431226" y="1998233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20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435761" y="166509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57">
            <a:extLst>
              <a:ext uri="{FF2B5EF4-FFF2-40B4-BE49-F238E27FC236}">
                <a16:creationId xmlns="" xmlns:a16="http://schemas.microsoft.com/office/drawing/2014/main" id="{EA12AD66-C48F-92E5-0BC2-30CDC77C617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42343" y="2614238"/>
            <a:ext cx="16009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514350"/>
            <a:r>
              <a:rPr lang="en-US" altLang="zh-CN" sz="1000" dirty="0">
                <a:cs typeface="Arial" panose="020B0604020202020204" pitchFamily="34" charset="0"/>
              </a:rPr>
              <a:t>mRNA abundance</a:t>
            </a:r>
            <a:r>
              <a:rPr lang="zh-CN" altLang="en-US" sz="1000" dirty="0">
                <a:cs typeface="Arial" panose="020B0604020202020204" pitchFamily="34" charset="0"/>
              </a:rPr>
              <a:t> </a:t>
            </a:r>
            <a:r>
              <a:rPr lang="en-US" altLang="zh-CN" sz="1000" dirty="0">
                <a:cs typeface="Arial" panose="020B0604020202020204" pitchFamily="34" charset="0"/>
              </a:rPr>
              <a:t>of</a:t>
            </a:r>
            <a:r>
              <a:rPr lang="zh-CN" altLang="en-US" sz="1000" dirty="0">
                <a:cs typeface="Arial" panose="020B0604020202020204" pitchFamily="34" charset="0"/>
              </a:rPr>
              <a:t> </a:t>
            </a:r>
            <a:endParaRPr lang="en-US" altLang="zh-CN" sz="1000" dirty="0">
              <a:cs typeface="Arial" panose="020B0604020202020204" pitchFamily="34" charset="0"/>
            </a:endParaRPr>
          </a:p>
          <a:p>
            <a:pPr algn="ctr" defTabSz="514350"/>
            <a:r>
              <a:rPr lang="en-US" altLang="zh-CN" sz="1000" i="1" dirty="0" smtClean="0"/>
              <a:t>Zm00001d048841 </a:t>
            </a:r>
            <a:r>
              <a:rPr lang="en-US" altLang="zh-CN" sz="1000" dirty="0" smtClean="0">
                <a:cs typeface="Arial" panose="020B0604020202020204" pitchFamily="34" charset="0"/>
              </a:rPr>
              <a:t>(FPKM</a:t>
            </a:r>
            <a:r>
              <a:rPr lang="en-US" altLang="zh-CN" sz="1000" dirty="0">
                <a:cs typeface="Arial" panose="020B0604020202020204" pitchFamily="34" charset="0"/>
              </a:rPr>
              <a:t>)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47" name="Rectangle 57">
            <a:extLst>
              <a:ext uri="{FF2B5EF4-FFF2-40B4-BE49-F238E27FC236}">
                <a16:creationId xmlns="" xmlns:a16="http://schemas.microsoft.com/office/drawing/2014/main" id="{EA12AD66-C48F-92E5-0BC2-30CDC77C617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28619" y="6004437"/>
            <a:ext cx="16009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514350"/>
            <a:r>
              <a:rPr lang="en-US" altLang="zh-CN" sz="1000" dirty="0">
                <a:cs typeface="Arial" panose="020B0604020202020204" pitchFamily="34" charset="0"/>
              </a:rPr>
              <a:t>mRNA abundance</a:t>
            </a:r>
            <a:r>
              <a:rPr lang="zh-CN" altLang="en-US" sz="1000" dirty="0">
                <a:cs typeface="Arial" panose="020B0604020202020204" pitchFamily="34" charset="0"/>
              </a:rPr>
              <a:t> </a:t>
            </a:r>
            <a:r>
              <a:rPr lang="en-US" altLang="zh-CN" sz="1000" dirty="0">
                <a:cs typeface="Arial" panose="020B0604020202020204" pitchFamily="34" charset="0"/>
              </a:rPr>
              <a:t>of</a:t>
            </a:r>
            <a:r>
              <a:rPr lang="zh-CN" altLang="en-US" sz="1000" dirty="0">
                <a:cs typeface="Arial" panose="020B0604020202020204" pitchFamily="34" charset="0"/>
              </a:rPr>
              <a:t> </a:t>
            </a:r>
            <a:endParaRPr lang="en-US" altLang="zh-CN" sz="1000" dirty="0">
              <a:cs typeface="Arial" panose="020B0604020202020204" pitchFamily="34" charset="0"/>
            </a:endParaRPr>
          </a:p>
          <a:p>
            <a:pPr algn="ctr" defTabSz="514350"/>
            <a:r>
              <a:rPr lang="en-US" altLang="zh-CN" sz="1000" i="1" dirty="0" smtClean="0"/>
              <a:t>Zm00001d048839 </a:t>
            </a:r>
            <a:r>
              <a:rPr lang="en-US" altLang="zh-CN" sz="1000" dirty="0" smtClean="0">
                <a:cs typeface="Arial" panose="020B0604020202020204" pitchFamily="34" charset="0"/>
              </a:rPr>
              <a:t>(FPKM</a:t>
            </a:r>
            <a:r>
              <a:rPr lang="en-US" altLang="zh-CN" sz="1000" dirty="0">
                <a:cs typeface="Arial" panose="020B0604020202020204" pitchFamily="34" charset="0"/>
              </a:rPr>
              <a:t>)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505240" y="8379149"/>
            <a:ext cx="565804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030423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51</Words>
  <Application>Microsoft Office PowerPoint</Application>
  <PresentationFormat>宽屏</PresentationFormat>
  <Paragraphs>4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7</cp:revision>
  <dcterms:created xsi:type="dcterms:W3CDTF">2022-11-14T00:46:01Z</dcterms:created>
  <dcterms:modified xsi:type="dcterms:W3CDTF">2022-11-29T02:37:14Z</dcterms:modified>
</cp:coreProperties>
</file>